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936" y="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>
  <p:cSld name="标题和表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770469"/>
            <a:ext cx="5772150" cy="81403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表格占位符 2"/>
          <p:cNvSpPr>
            <a:spLocks noGrp="1"/>
          </p:cNvSpPr>
          <p:nvPr>
            <p:ph type="tbl" idx="1"/>
          </p:nvPr>
        </p:nvSpPr>
        <p:spPr>
          <a:xfrm>
            <a:off x="342900" y="2091267"/>
            <a:ext cx="6172200" cy="6934200"/>
          </a:xfrm>
        </p:spPr>
        <p:txBody>
          <a:bodyPr>
            <a:normAutofit/>
          </a:bodyPr>
          <a:lstStyle/>
          <a:p>
            <a:pPr lvl="0"/>
            <a:r>
              <a:rPr lang="zh-CN" altLang="en-US" noProof="0" smtClean="0"/>
              <a:t>单击图标添加表格</a:t>
            </a:r>
            <a:endParaRPr lang="zh-CN" altLang="en-US" noProof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xfrm>
            <a:off x="342900" y="9470321"/>
            <a:ext cx="1600200" cy="353131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xfrm>
            <a:off x="5372100" y="220133"/>
            <a:ext cx="1314450" cy="3302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zh-CN"/>
              <a:t>Company Logo</a:t>
            </a: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>
          <a:xfrm>
            <a:off x="2571750" y="9470321"/>
            <a:ext cx="1600200" cy="353131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47800B-6348-4B7A-84F3-F5A35DF97CF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2C371-BB87-4936-82F9-86FBE94DBE8E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C5DFF-85BD-46F4-BBA2-6DA9029A5CE7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1054523" y="1496615"/>
          <a:ext cx="4778175" cy="298832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41668"/>
                <a:gridCol w="341668"/>
                <a:gridCol w="336491"/>
                <a:gridCol w="341668"/>
                <a:gridCol w="341668"/>
                <a:gridCol w="341668"/>
                <a:gridCol w="341668"/>
                <a:gridCol w="341668"/>
                <a:gridCol w="341668"/>
                <a:gridCol w="341668"/>
                <a:gridCol w="341668"/>
                <a:gridCol w="341668"/>
                <a:gridCol w="341668"/>
                <a:gridCol w="341668"/>
              </a:tblGrid>
              <a:tr h="213452"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H1</a:t>
                      </a:r>
                      <a:endParaRPr lang="zh-CN" altLang="en-US" sz="800" b="1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2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1/5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2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3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2/6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3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4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4/96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7/5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4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5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3/81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2/5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5/8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5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6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4/54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2/7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92/9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6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6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7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0/50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91/9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1/6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2/5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2/5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1/7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7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8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6/86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6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8/8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90/9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6/56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8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9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2/52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2/8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4/7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4/7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2/8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9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0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2/52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2/8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4/7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4/7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1/8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90/9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0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1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0/50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68/7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2/6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1/5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2/6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67/7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79/86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80/86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1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800" b="1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2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5/6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6/6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5/6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7/6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2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3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0/5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6/6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1/6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2/5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50/66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6/6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4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7/6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7/6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7/6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2/5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3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3452">
                <a:tc>
                  <a:txBody>
                    <a:bodyPr/>
                    <a:lstStyle/>
                    <a:p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H14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6/6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6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6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7/6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5/6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6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7/6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5/5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6/5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5/53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3/95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3/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36000" marR="36000" marT="39000" marB="39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912912" y="1208585"/>
            <a:ext cx="466399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able S6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Pairwis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comparison of the GmaPHO1 protein family.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08162" y="4520952"/>
            <a:ext cx="48965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Arial" pitchFamily="34" charset="0"/>
                <a:cs typeface="Arial" pitchFamily="34" charset="0"/>
              </a:rPr>
              <a:t>Pairwise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comparison of the GmaPHO1 protein family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showed amino acid sequence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homology: identity (left) and similarity (right) . H1-H14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are abbreviated for GmaPHO1; H1-H14 proteins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.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59</Words>
  <Application>Microsoft Office PowerPoint</Application>
  <PresentationFormat>A4 纸张(210x297 毫米)</PresentationFormat>
  <Paragraphs>11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zhongkeyu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elingli</dc:creator>
  <cp:lastModifiedBy>unknown</cp:lastModifiedBy>
  <cp:revision>6</cp:revision>
  <dcterms:created xsi:type="dcterms:W3CDTF">2013-03-30T10:54:00Z</dcterms:created>
  <dcterms:modified xsi:type="dcterms:W3CDTF">2013-05-21T07:07:59Z</dcterms:modified>
</cp:coreProperties>
</file>